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92F406-D521-42F3-8DFD-91FFD478A52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C4FB8E-A70B-4DE4-AB55-4DF93A3BC8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41A8C2-D9BF-4C87-878F-F63493BD5F9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3AD5FA-BB20-414F-BA1A-5792E78D4B4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3C55BA-74CE-42F8-8201-7989080C55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C85BC9-AFD7-4747-96DF-6CBD279F38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EEC1FC-4463-4586-B18F-F4345EA88A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BE3EA3-9BC9-4470-9472-B84261ACCB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7947F3-1BD1-4D62-B58F-1B7EAF4B23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54ED84-32CA-43EC-8784-96BC048831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B2FC0C-1921-48F8-A8E8-85192D1433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CBBCD5-4F8F-4FEC-997E-437ECE1110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CDD98AD-EFF8-46B0-8DBE-21A2EE62EE9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611280" y="485640"/>
            <a:ext cx="8029440" cy="6384600"/>
            <a:chOff x="611280" y="485640"/>
            <a:chExt cx="8029440" cy="6384600"/>
          </a:xfrm>
        </p:grpSpPr>
        <p:sp>
          <p:nvSpPr>
            <p:cNvPr id="42" name=""/>
            <p:cNvSpPr/>
            <p:nvPr/>
          </p:nvSpPr>
          <p:spPr>
            <a:xfrm>
              <a:off x="5049720" y="6647040"/>
              <a:ext cx="787680" cy="223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rmAutofit/>
            </a:bodyPr>
            <a:p>
              <a:pPr algn="ctr">
                <a:spcBef>
                  <a:spcPts val="7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7415280" y="6402960"/>
              <a:ext cx="1168200" cy="223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eeding lin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5894280" y="6402960"/>
              <a:ext cx="1473480" cy="223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ochow-KWS compan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5049720" y="6152400"/>
              <a:ext cx="787680" cy="223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rmAutofit/>
            </a:bodyPr>
            <a:p>
              <a:pPr algn="ctr">
                <a:spcBef>
                  <a:spcPts val="7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576440" y="6402960"/>
              <a:ext cx="3416400" cy="223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ochow-KWS breeding lin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723960" y="6402960"/>
              <a:ext cx="852480" cy="223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P101, LP102, LP103, LP104, LP105, LP106, LP107, LP108, LP109, LP1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7415280" y="5943600"/>
              <a:ext cx="11682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5894280" y="5943600"/>
              <a:ext cx="14734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TURKMENIST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5049720" y="5943600"/>
              <a:ext cx="7876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10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1576440" y="5943600"/>
              <a:ext cx="34164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ordeum vulgare subsp. spontane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723960" y="5943600"/>
              <a:ext cx="8524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s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7415280" y="5842800"/>
              <a:ext cx="11682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894280" y="5842800"/>
              <a:ext cx="1473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JORD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049720" y="5842800"/>
              <a:ext cx="7876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03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576440" y="5842800"/>
              <a:ext cx="34164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ordeum vulgare subsp. spontane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723960" y="5842800"/>
              <a:ext cx="852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s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7415280" y="5750280"/>
              <a:ext cx="11682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5894280" y="5750280"/>
              <a:ext cx="14734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JORD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5049720" y="5750280"/>
              <a:ext cx="7876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03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576440" y="5750280"/>
              <a:ext cx="34164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ordeum vulgare subsp. spontane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723960" y="5750280"/>
              <a:ext cx="8524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s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7415280" y="5640120"/>
              <a:ext cx="11682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5894280" y="5640120"/>
              <a:ext cx="1473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JORD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5049720" y="5640120"/>
              <a:ext cx="7876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01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576440" y="5640120"/>
              <a:ext cx="34164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ordeum vulgare subsp. spontane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723960" y="5640120"/>
              <a:ext cx="852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s4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7415280" y="5529960"/>
              <a:ext cx="11682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5894280" y="5529960"/>
              <a:ext cx="1473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JORD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5049720" y="5529960"/>
              <a:ext cx="7876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03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1576440" y="5529960"/>
              <a:ext cx="34164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ordeum vulgare subsp. spontane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723960" y="5529960"/>
              <a:ext cx="852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s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7415280" y="5410800"/>
              <a:ext cx="11682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5894280" y="5410800"/>
              <a:ext cx="1473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JORD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5049720" y="5410800"/>
              <a:ext cx="7876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02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1576440" y="5410800"/>
              <a:ext cx="34164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ordeum vulgare subsp. spontane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723960" y="5410800"/>
              <a:ext cx="852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s2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7415280" y="5291280"/>
              <a:ext cx="11682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5894280" y="5291280"/>
              <a:ext cx="1473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RAQ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5049720" y="5291280"/>
              <a:ext cx="7876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742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1576440" y="5291280"/>
              <a:ext cx="34164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ordeum vulgare subsp. spontane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723960" y="5291280"/>
              <a:ext cx="852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s1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7415280" y="5055840"/>
              <a:ext cx="1168200" cy="223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ent of IL populat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5894280" y="5055840"/>
              <a:ext cx="1473480" cy="223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rmAutofit/>
            </a:bodyPr>
            <a:p>
              <a:pPr algn="ctr">
                <a:spcBef>
                  <a:spcPts val="7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5049720" y="5055840"/>
              <a:ext cx="787680" cy="223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rmAutofit/>
            </a:bodyPr>
            <a:p>
              <a:pPr algn="ctr">
                <a:spcBef>
                  <a:spcPts val="7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1576440" y="5055840"/>
              <a:ext cx="3416400" cy="223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ent used for creating BHS584 introgression line populat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723960" y="5055840"/>
              <a:ext cx="852480" cy="223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s 584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7415280" y="5070960"/>
              <a:ext cx="11682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5894280" y="5070960"/>
              <a:ext cx="14734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ARD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5049720" y="5070960"/>
              <a:ext cx="7876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7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576440" y="5070960"/>
              <a:ext cx="34164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Zanbaka//SLB45-40/H.spont.41-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723960" y="5070960"/>
              <a:ext cx="8524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3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7415280" y="4942800"/>
              <a:ext cx="11682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5894280" y="4942800"/>
              <a:ext cx="14734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ARD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5049720" y="4942800"/>
              <a:ext cx="7876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6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1576440" y="4942800"/>
              <a:ext cx="34164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.spont.41-1/Tadmo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723960" y="4942800"/>
              <a:ext cx="8524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3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7415280" y="4823640"/>
              <a:ext cx="11682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5894280" y="4823640"/>
              <a:ext cx="14734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ARD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5049720" y="4823640"/>
              <a:ext cx="7876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6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1576440" y="4823640"/>
              <a:ext cx="34164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rta/H.spont.41-5/Tadmo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723960" y="4823640"/>
              <a:ext cx="8524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3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7415280" y="4713480"/>
              <a:ext cx="11682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5894280" y="4713480"/>
              <a:ext cx="1473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ERITRE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5049720" y="4713480"/>
              <a:ext cx="7876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6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1576440" y="4713480"/>
              <a:ext cx="34164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s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723960" y="4713480"/>
              <a:ext cx="852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7415280" y="4603320"/>
              <a:ext cx="11682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5894280" y="4603320"/>
              <a:ext cx="1473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ETHIOPI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5049720" y="4603320"/>
              <a:ext cx="7876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6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1576440" y="4603320"/>
              <a:ext cx="34164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heg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723960" y="4603320"/>
              <a:ext cx="852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2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7415280" y="4492800"/>
              <a:ext cx="11682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5894280" y="4492800"/>
              <a:ext cx="14734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USTRALI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5049720" y="4492800"/>
              <a:ext cx="7876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6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1576440" y="4492800"/>
              <a:ext cx="34164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Barqu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723960" y="4492800"/>
              <a:ext cx="8524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2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7415280" y="4400640"/>
              <a:ext cx="11682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5894280" y="4400640"/>
              <a:ext cx="1473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YRI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5049720" y="4400640"/>
              <a:ext cx="7876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5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1576440" y="4400640"/>
              <a:ext cx="34164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Furat-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723960" y="4400640"/>
              <a:ext cx="852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2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7415280" y="4281480"/>
              <a:ext cx="11682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5894280" y="4281480"/>
              <a:ext cx="14734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BAN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5049720" y="4281480"/>
              <a:ext cx="7876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5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1576440" y="4281480"/>
              <a:ext cx="34164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itan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723960" y="4281480"/>
              <a:ext cx="8524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2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7415280" y="4153320"/>
              <a:ext cx="11682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5894280" y="4153320"/>
              <a:ext cx="1473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ARD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5049720" y="4153320"/>
              <a:ext cx="7876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5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1576440" y="4153320"/>
              <a:ext cx="34164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omtaz = (M 126/CM67//As/Pro/3/Alanda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723960" y="4153320"/>
              <a:ext cx="852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2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7415280" y="4051800"/>
              <a:ext cx="11682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5894280" y="4051800"/>
              <a:ext cx="1473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IBY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5049720" y="4051800"/>
              <a:ext cx="7876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5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1576440" y="4051800"/>
              <a:ext cx="34164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Kata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723960" y="4051800"/>
              <a:ext cx="852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2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7415280" y="3914640"/>
              <a:ext cx="11682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5894280" y="3914640"/>
              <a:ext cx="14734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ARD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5049720" y="3914640"/>
              <a:ext cx="7876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5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1576440" y="3914640"/>
              <a:ext cx="34164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adik-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723960" y="3914640"/>
              <a:ext cx="8524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2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7415280" y="3777840"/>
              <a:ext cx="11682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5894280" y="3777840"/>
              <a:ext cx="1473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YRI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5049720" y="3777840"/>
              <a:ext cx="7876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4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1576440" y="3777840"/>
              <a:ext cx="34164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Furat-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723960" y="3777840"/>
              <a:ext cx="852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2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7415280" y="3658680"/>
              <a:ext cx="11682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5894280" y="3658680"/>
              <a:ext cx="1473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REEC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5049720" y="3658680"/>
              <a:ext cx="7876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4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1576440" y="3658680"/>
              <a:ext cx="34164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h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723960" y="3658680"/>
              <a:ext cx="852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2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7415280" y="3530520"/>
              <a:ext cx="11682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5894280" y="3530520"/>
              <a:ext cx="1473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EGYP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5049720" y="3530520"/>
              <a:ext cx="7876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4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1576440" y="3530520"/>
              <a:ext cx="34164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alM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723960" y="3530520"/>
              <a:ext cx="852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19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7415280" y="3402360"/>
              <a:ext cx="11682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5894280" y="3402360"/>
              <a:ext cx="14734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ARD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5049720" y="3402360"/>
              <a:ext cx="7876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1576440" y="3402360"/>
              <a:ext cx="34164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atnan-0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723960" y="3402360"/>
              <a:ext cx="8524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1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7415280" y="3274200"/>
              <a:ext cx="11682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5894280" y="3274200"/>
              <a:ext cx="14734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TURKE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5049720" y="3274200"/>
              <a:ext cx="7876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3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1576440" y="3274200"/>
              <a:ext cx="34164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Bulbu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723960" y="3274200"/>
              <a:ext cx="8524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1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7415280" y="3146040"/>
              <a:ext cx="11682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5894280" y="3146040"/>
              <a:ext cx="1473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TURKE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5049720" y="3146040"/>
              <a:ext cx="7876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1576440" y="3146040"/>
              <a:ext cx="34164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Toka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723960" y="3146040"/>
              <a:ext cx="852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7415280" y="3026880"/>
              <a:ext cx="11682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5894280" y="3018240"/>
              <a:ext cx="1473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RAQ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5049720" y="3026880"/>
              <a:ext cx="7876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3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1576440" y="3026880"/>
              <a:ext cx="34164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PA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723960" y="3026880"/>
              <a:ext cx="8524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14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7415280" y="2916720"/>
              <a:ext cx="11682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5894280" y="2916720"/>
              <a:ext cx="1473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FRANC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5049720" y="2916720"/>
              <a:ext cx="7876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3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1576440" y="2916720"/>
              <a:ext cx="34164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Expres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723960" y="2916720"/>
              <a:ext cx="852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1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7415280" y="2788920"/>
              <a:ext cx="11682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5894280" y="2788920"/>
              <a:ext cx="1473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ARD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5049720" y="2788920"/>
              <a:ext cx="7876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3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1576440" y="2788920"/>
              <a:ext cx="34164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Badi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723960" y="2788920"/>
              <a:ext cx="852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12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7415280" y="2651760"/>
              <a:ext cx="11682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5894280" y="2651760"/>
              <a:ext cx="1473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LGERI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5049720" y="2651760"/>
              <a:ext cx="7876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1576440" y="2651760"/>
              <a:ext cx="34164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Tichedret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723960" y="2651760"/>
              <a:ext cx="852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7415280" y="2523600"/>
              <a:ext cx="11682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5894280" y="2523600"/>
              <a:ext cx="1473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ARD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5049720" y="2523600"/>
              <a:ext cx="7876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2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1576440" y="2523600"/>
              <a:ext cx="34164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landa-0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723960" y="2523600"/>
              <a:ext cx="852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7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7415280" y="2395080"/>
              <a:ext cx="11682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5894280" y="2395080"/>
              <a:ext cx="14734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ARD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5049720" y="2395080"/>
              <a:ext cx="7876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2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1576440" y="2395080"/>
              <a:ext cx="34164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Rihane-0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723960" y="2395080"/>
              <a:ext cx="8524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6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7415280" y="2249280"/>
              <a:ext cx="1168200" cy="107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5894280" y="2124360"/>
              <a:ext cx="1473480" cy="223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ARD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5049720" y="2249280"/>
              <a:ext cx="787680" cy="107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723960" y="2249280"/>
              <a:ext cx="852480" cy="107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7415280" y="2130480"/>
              <a:ext cx="11682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5894280" y="2130480"/>
              <a:ext cx="1473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ARD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5049720" y="2130480"/>
              <a:ext cx="7876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1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1576440" y="2130480"/>
              <a:ext cx="341640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Zanbak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723960" y="2130480"/>
              <a:ext cx="852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7415280" y="1966320"/>
              <a:ext cx="11682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5894280" y="1966320"/>
              <a:ext cx="14734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ARD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5049720" y="1966320"/>
              <a:ext cx="7876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1576440" y="1966320"/>
              <a:ext cx="341640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Tadmo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723960" y="1966320"/>
              <a:ext cx="852480" cy="92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7415280" y="1829520"/>
              <a:ext cx="1168200" cy="101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5894280" y="1829520"/>
              <a:ext cx="1473480" cy="101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ARD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5049720" y="1829520"/>
              <a:ext cx="787680" cy="101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82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1576440" y="1829520"/>
              <a:ext cx="3416400" cy="101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. spont. 41-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723960" y="1829520"/>
              <a:ext cx="852480" cy="101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1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7415280" y="1611720"/>
              <a:ext cx="1168200" cy="181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aturally occurred field mutation lin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1576440" y="1611720"/>
              <a:ext cx="3416400" cy="181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ansformation lin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733320" y="1611720"/>
              <a:ext cx="852480" cy="181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 Goldenpr.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7415280" y="1447920"/>
              <a:ext cx="1168200" cy="119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eeding line, parent of I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1576440" y="1447920"/>
              <a:ext cx="3416400" cy="119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ent used for creating BHS584 introgression line populat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723960" y="1447920"/>
              <a:ext cx="852480" cy="119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 Brenda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7415280" y="1310760"/>
              <a:ext cx="1168200" cy="119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1576440" y="1310760"/>
              <a:ext cx="3416400" cy="119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ent mapping population, H. Vulgar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723960" y="1310760"/>
              <a:ext cx="852480" cy="119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 Steptoe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7415280" y="1146960"/>
              <a:ext cx="1168200" cy="145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1576440" y="1146960"/>
              <a:ext cx="3416400" cy="145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ent mapping population, H. Vulgar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723960" y="1146960"/>
              <a:ext cx="852480" cy="145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 MOREX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7415280" y="1018800"/>
              <a:ext cx="1168200" cy="136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5894280" y="1313640"/>
              <a:ext cx="1473480" cy="48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rmAutofit/>
            </a:bodyPr>
            <a:p>
              <a:pPr algn="ctr">
                <a:spcBef>
                  <a:spcPts val="7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1576440" y="1018800"/>
              <a:ext cx="3416400" cy="136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ent mapping population, H. Vulgar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723960" y="1018800"/>
              <a:ext cx="852480" cy="136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RE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7415280" y="828000"/>
              <a:ext cx="1168200" cy="164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ebank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1576440" y="828000"/>
              <a:ext cx="3416400" cy="164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ent mapping population, H. Vulgar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723960" y="828000"/>
              <a:ext cx="852480" cy="164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vDO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7415280" y="513720"/>
              <a:ext cx="1168200" cy="23364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Typ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5894280" y="513720"/>
              <a:ext cx="1473480" cy="23364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orig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5049720" y="513720"/>
              <a:ext cx="787680" cy="23364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G-numbe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1576440" y="513720"/>
              <a:ext cx="3416400" cy="23364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ultivar/variety nam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638280" y="513720"/>
              <a:ext cx="852480" cy="23364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ultivar/variety cod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 flipH="1">
              <a:off x="619200" y="485640"/>
              <a:ext cx="9360" cy="6238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628560" y="485640"/>
              <a:ext cx="8010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620640" y="772920"/>
              <a:ext cx="8010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 flipH="1">
              <a:off x="8631360" y="494640"/>
              <a:ext cx="9360" cy="6238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611280" y="6726240"/>
              <a:ext cx="8010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51" name=""/>
          <p:cNvSpPr/>
          <p:nvPr/>
        </p:nvSpPr>
        <p:spPr>
          <a:xfrm>
            <a:off x="603360" y="153360"/>
            <a:ext cx="7526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ditional file 8 (AF8 gene bank accession details.ppt) Detailed list of accessions, their origin and IG-number is provided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28T13:30:34Z</dcterms:created>
  <dc:creator> </dc:creator>
  <dc:description/>
  <dc:language>en-US</dc:language>
  <cp:lastModifiedBy>srinivas</cp:lastModifiedBy>
  <dcterms:modified xsi:type="dcterms:W3CDTF">2010-09-14T17:17:32Z</dcterms:modified>
  <cp:revision>14</cp:revision>
  <dc:subject/>
  <dc:title>Slide 1</dc:title>
</cp:coreProperties>
</file>